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53" r:id="rId1"/>
  </p:sldMasterIdLst>
  <p:notesMasterIdLst>
    <p:notesMasterId r:id="rId3"/>
  </p:notesMasterIdLst>
  <p:handoutMasterIdLst>
    <p:handoutMasterId r:id="rId4"/>
  </p:handoutMasterIdLst>
  <p:sldIdLst>
    <p:sldId id="302" r:id="rId2"/>
  </p:sldIdLst>
  <p:sldSz cx="10287000" cy="6858000" type="35mm"/>
  <p:notesSz cx="6805613" cy="9939338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981">
          <p15:clr>
            <a:srgbClr val="A4A3A4"/>
          </p15:clr>
        </p15:guide>
        <p15:guide id="2" pos="609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00CC"/>
    <a:srgbClr val="EAEAEA"/>
    <a:srgbClr val="D7792C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中間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F2DE63D5-997A-4646-A377-4702673A728D}" styleName="淡色 2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2D5ABB26-0587-4C30-8999-92F81FD0307C}" styleName="スタイル/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8768" autoAdjust="0"/>
    <p:restoredTop sz="92806" autoAdjust="0"/>
  </p:normalViewPr>
  <p:slideViewPr>
    <p:cSldViewPr>
      <p:cViewPr>
        <p:scale>
          <a:sx n="90" d="100"/>
          <a:sy n="90" d="100"/>
        </p:scale>
        <p:origin x="-390" y="-330"/>
      </p:cViewPr>
      <p:guideLst>
        <p:guide orient="horz" pos="981"/>
        <p:guide pos="609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chinenyoshiaki:Documents:&#12510;&#12472;&#12483;&#12463;%20&#12502;&#12522;&#12540;&#12501;&#12465;&#12540;&#12473;:&#22338;&#20803;&#35542;&#25991;:&#22338;&#20803;real%20tim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2433719485714"/>
          <c:y val="6.0185185185185203E-2"/>
          <c:w val="0.85280095140943901"/>
          <c:h val="0.8239202391367750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heet4 (2)'!$L$11</c:f>
              <c:strCache>
                <c:ptCount val="1"/>
                <c:pt idx="0">
                  <c:v>NSE 2-3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heet4 (2)'!$M$15:$O$15</c:f>
                <c:numCache>
                  <c:formatCode>General</c:formatCode>
                  <c:ptCount val="3"/>
                  <c:pt idx="0">
                    <c:v>1.290782007466168</c:v>
                  </c:pt>
                  <c:pt idx="1">
                    <c:v>0.1156393655304</c:v>
                  </c:pt>
                  <c:pt idx="2">
                    <c:v>0.261072459038105</c:v>
                  </c:pt>
                </c:numCache>
              </c:numRef>
            </c:plus>
            <c:minus>
              <c:numRef>
                <c:f>'Sheet4 (2)'!$M$15:$O$15</c:f>
                <c:numCache>
                  <c:formatCode>General</c:formatCode>
                  <c:ptCount val="3"/>
                  <c:pt idx="0">
                    <c:v>1.290782007466168</c:v>
                  </c:pt>
                  <c:pt idx="1">
                    <c:v>0.1156393655304</c:v>
                  </c:pt>
                  <c:pt idx="2">
                    <c:v>0.261072459038105</c:v>
                  </c:pt>
                </c:numCache>
              </c:numRef>
            </c:minus>
          </c:errBars>
          <c:cat>
            <c:strRef>
              <c:f>'Sheet4 (2)'!$M$10:$P$10</c:f>
              <c:strCache>
                <c:ptCount val="4"/>
                <c:pt idx="0">
                  <c:v>Patient1</c:v>
                </c:pt>
                <c:pt idx="1">
                  <c:v>HL60</c:v>
                </c:pt>
                <c:pt idx="2">
                  <c:v>KG1</c:v>
                </c:pt>
                <c:pt idx="3">
                  <c:v>Normal BM</c:v>
                </c:pt>
              </c:strCache>
            </c:strRef>
          </c:cat>
          <c:val>
            <c:numRef>
              <c:f>'Sheet4 (2)'!$M$11:$P$11</c:f>
              <c:numCache>
                <c:formatCode>General</c:formatCode>
                <c:ptCount val="4"/>
                <c:pt idx="0">
                  <c:v>23.573395241095859</c:v>
                </c:pt>
                <c:pt idx="1">
                  <c:v>0.237776562223245</c:v>
                </c:pt>
                <c:pt idx="2">
                  <c:v>0.54957698051750203</c:v>
                </c:pt>
                <c:pt idx="3">
                  <c:v>1</c:v>
                </c:pt>
              </c:numCache>
            </c:numRef>
          </c:val>
        </c:ser>
        <c:ser>
          <c:idx val="1"/>
          <c:order val="1"/>
          <c:tx>
            <c:strRef>
              <c:f>'Sheet4 (2)'!$L$12</c:f>
              <c:strCache>
                <c:ptCount val="1"/>
                <c:pt idx="0">
                  <c:v>NSE 7-8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heet4 (2)'!$M$16:$O$16</c:f>
                <c:numCache>
                  <c:formatCode>General</c:formatCode>
                  <c:ptCount val="3"/>
                  <c:pt idx="0">
                    <c:v>8.3940670091469443</c:v>
                  </c:pt>
                  <c:pt idx="1">
                    <c:v>0.30309501284502799</c:v>
                  </c:pt>
                  <c:pt idx="2">
                    <c:v>0.116816194758653</c:v>
                  </c:pt>
                </c:numCache>
              </c:numRef>
            </c:plus>
            <c:minus>
              <c:numRef>
                <c:f>'Sheet4 (2)'!$M$16:$O$16</c:f>
                <c:numCache>
                  <c:formatCode>General</c:formatCode>
                  <c:ptCount val="3"/>
                  <c:pt idx="0">
                    <c:v>8.3940670091469443</c:v>
                  </c:pt>
                  <c:pt idx="1">
                    <c:v>0.30309501284502799</c:v>
                  </c:pt>
                  <c:pt idx="2">
                    <c:v>0.116816194758653</c:v>
                  </c:pt>
                </c:numCache>
              </c:numRef>
            </c:minus>
          </c:errBars>
          <c:cat>
            <c:strRef>
              <c:f>'Sheet4 (2)'!$M$10:$P$10</c:f>
              <c:strCache>
                <c:ptCount val="4"/>
                <c:pt idx="0">
                  <c:v>Patient1</c:v>
                </c:pt>
                <c:pt idx="1">
                  <c:v>HL60</c:v>
                </c:pt>
                <c:pt idx="2">
                  <c:v>KG1</c:v>
                </c:pt>
                <c:pt idx="3">
                  <c:v>Normal BM</c:v>
                </c:pt>
              </c:strCache>
            </c:strRef>
          </c:cat>
          <c:val>
            <c:numRef>
              <c:f>'Sheet4 (2)'!$M$12:$P$12</c:f>
              <c:numCache>
                <c:formatCode>General</c:formatCode>
                <c:ptCount val="4"/>
                <c:pt idx="0">
                  <c:v>62.633531726363003</c:v>
                </c:pt>
                <c:pt idx="1">
                  <c:v>0.53012460754783597</c:v>
                </c:pt>
                <c:pt idx="2">
                  <c:v>0.71170593801786997</c:v>
                </c:pt>
                <c:pt idx="3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3589888"/>
        <c:axId val="93591424"/>
      </c:barChart>
      <c:catAx>
        <c:axId val="93589888"/>
        <c:scaling>
          <c:orientation val="minMax"/>
        </c:scaling>
        <c:delete val="0"/>
        <c:axPos val="b"/>
        <c:majorTickMark val="out"/>
        <c:minorTickMark val="none"/>
        <c:tickLblPos val="nextTo"/>
        <c:crossAx val="93591424"/>
        <c:crossesAt val="0.1"/>
        <c:auto val="1"/>
        <c:lblAlgn val="ctr"/>
        <c:lblOffset val="100"/>
        <c:noMultiLvlLbl val="0"/>
      </c:catAx>
      <c:valAx>
        <c:axId val="93591424"/>
        <c:scaling>
          <c:logBase val="10"/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9358988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1190423286301496"/>
          <c:y val="0.13401246719160101"/>
          <c:w val="0.17906747735100101"/>
          <c:h val="0.17641951006124201"/>
        </c:manualLayout>
      </c:layout>
      <c:overlay val="0"/>
      <c:spPr>
        <a:ln>
          <a:solidFill>
            <a:schemeClr val="tx1">
              <a:lumMod val="50000"/>
              <a:lumOff val="50000"/>
            </a:schemeClr>
          </a:solidFill>
        </a:ln>
      </c:spPr>
    </c:legend>
    <c:plotVisOnly val="1"/>
    <c:dispBlanksAs val="gap"/>
    <c:showDLblsOverMax val="0"/>
  </c:chart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53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9575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553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4450" y="0"/>
            <a:ext cx="2949575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08D3D4F2-F19B-48B3-8455-13D2547BDE7B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6554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40863"/>
            <a:ext cx="2949575" cy="49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554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4450" y="9440863"/>
            <a:ext cx="2949575" cy="49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89E46D3A-56EC-421A-8A11-6A21FE30D27C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66394972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4450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ea typeface="ＭＳ Ｐゴシック" pitchFamily="50" charset="-128"/>
              </a:defRPr>
            </a:lvl1pPr>
          </a:lstStyle>
          <a:p>
            <a:pPr>
              <a:defRPr/>
            </a:pPr>
            <a:fld id="{A02D4FD3-2E6E-4464-B901-18CBEA3BA936}" type="datetimeFigureOut">
              <a:rPr lang="ja-JP" altLang="en-US"/>
              <a:pPr>
                <a:defRPr/>
              </a:pPr>
              <a:t>2014/8/30</a:t>
            </a:fld>
            <a:endParaRPr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08013" y="746125"/>
            <a:ext cx="5589587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21225"/>
            <a:ext cx="5443537" cy="447198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 noProof="0" smtClean="0"/>
              <a:t>マスター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  <a:endParaRPr lang="ja-JP" altLang="en-US" noProof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4450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ea typeface="ＭＳ Ｐゴシック" pitchFamily="50" charset="-128"/>
              </a:defRPr>
            </a:lvl1pPr>
          </a:lstStyle>
          <a:p>
            <a:pPr>
              <a:defRPr/>
            </a:pPr>
            <a:fld id="{42A85478-476D-4216-91F0-4AA3CA62082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39215979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71525" y="2130425"/>
            <a:ext cx="8743950" cy="1470025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43050" y="3886200"/>
            <a:ext cx="72009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F729937-A30B-4A1E-99A7-B4274F403A28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6AAA506-2BC8-46B8-A683-D8252628EC78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A4D9968-A038-4277-8E57-E9FE441DACC2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1748EFE-AD83-4466-B750-D723D6FC79DD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458075" y="274638"/>
            <a:ext cx="2314575" cy="5849937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514350" y="274638"/>
            <a:ext cx="6791325" cy="5849937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4A93002-9E29-4536-9AAE-CFDB31B61BBC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488ED9E-A972-407E-8A93-D9120D13A456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CDF740-D52F-4674-962B-4CC57B376945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87FE842-2234-41FD-9BA1-CA1403E35223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12800" y="4406900"/>
            <a:ext cx="874395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812800" y="2906713"/>
            <a:ext cx="874395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8607E27-1C02-4436-BFB8-C52ED1F545F7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030422-497E-4942-8B60-7DC684210531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514350" y="1600200"/>
            <a:ext cx="4552950" cy="45243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5219700" y="1600200"/>
            <a:ext cx="4552950" cy="45243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4A1D54F-5883-4C4E-B64C-B9AE715E4CA4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F48308D-8869-4276-859A-942D1C2E2A93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14350" y="1535113"/>
            <a:ext cx="454501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514350" y="2174875"/>
            <a:ext cx="454501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5226050" y="1535113"/>
            <a:ext cx="454660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5226050" y="2174875"/>
            <a:ext cx="454660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1F729A0-6FC3-41A9-8DD4-91D4B14905C6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BB68A35-81F0-457F-882A-8C75AC1ECF5F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4C0CEBE-3F2A-4176-9B4B-EAF3EE714F5C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232E00F-005A-4387-8965-A16AF88ACFDB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774B373-3BA9-4D3F-AEE3-44188C49A1D7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D766F42-ECF0-4FD2-A398-102F7976612B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0" y="273050"/>
            <a:ext cx="3384550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4022725" y="273050"/>
            <a:ext cx="5749925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514350" y="1435100"/>
            <a:ext cx="3384550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4CAB195-BF36-4024-9009-29056ADB5A1B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D0F061B-A3EC-49BE-8655-A6F58627058E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016125" y="4800600"/>
            <a:ext cx="6172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2016125" y="612775"/>
            <a:ext cx="6172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2016125" y="5367338"/>
            <a:ext cx="6172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18CF759-4639-4A18-A712-4C621E2BEEDE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01958BE-37CE-4C45-9FEE-318023AB72F0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02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274638"/>
            <a:ext cx="92583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25603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1600200"/>
            <a:ext cx="9258300" cy="4524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70660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6246813"/>
            <a:ext cx="24003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fld id="{29E6E93A-4BC8-4D2F-B3B4-293D6F4E0B7F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70661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514725" y="6246813"/>
            <a:ext cx="325755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0662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7372350" y="6246813"/>
            <a:ext cx="24003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66543146-941F-4EAF-A99C-92087B6213C7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91" r:id="rId1"/>
    <p:sldLayoutId id="2147483690" r:id="rId2"/>
    <p:sldLayoutId id="2147483689" r:id="rId3"/>
    <p:sldLayoutId id="2147483688" r:id="rId4"/>
    <p:sldLayoutId id="2147483687" r:id="rId5"/>
    <p:sldLayoutId id="2147483686" r:id="rId6"/>
    <p:sldLayoutId id="2147483685" r:id="rId7"/>
    <p:sldLayoutId id="2147483684" r:id="rId8"/>
    <p:sldLayoutId id="2147483683" r:id="rId9"/>
    <p:sldLayoutId id="2147483682" r:id="rId10"/>
    <p:sldLayoutId id="2147483681" r:id="rId11"/>
  </p:sldLayoutIdLst>
  <p:txStyles>
    <p:titleStyle>
      <a:lvl1pPr algn="ctr" defTabSz="912813" rtl="0" eaLnBrk="0" fontAlgn="base" hangingPunct="0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+mj-lt"/>
          <a:ea typeface="+mj-ea"/>
          <a:cs typeface="+mj-cs"/>
        </a:defRPr>
      </a:lvl1pPr>
      <a:lvl2pPr algn="ctr" defTabSz="912813" rtl="0" eaLnBrk="0" fontAlgn="base" hangingPunct="0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Arial" charset="0"/>
          <a:ea typeface="ＭＳ Ｐゴシック" charset="-128"/>
        </a:defRPr>
      </a:lvl2pPr>
      <a:lvl3pPr algn="ctr" defTabSz="912813" rtl="0" eaLnBrk="0" fontAlgn="base" hangingPunct="0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Arial" charset="0"/>
          <a:ea typeface="ＭＳ Ｐゴシック" charset="-128"/>
        </a:defRPr>
      </a:lvl3pPr>
      <a:lvl4pPr algn="ctr" defTabSz="912813" rtl="0" eaLnBrk="0" fontAlgn="base" hangingPunct="0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Arial" charset="0"/>
          <a:ea typeface="ＭＳ Ｐゴシック" charset="-128"/>
        </a:defRPr>
      </a:lvl4pPr>
      <a:lvl5pPr algn="ctr" defTabSz="912813" rtl="0" eaLnBrk="0" fontAlgn="base" hangingPunct="0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Arial" charset="0"/>
          <a:ea typeface="ＭＳ Ｐゴシック" charset="-128"/>
        </a:defRPr>
      </a:lvl5pPr>
      <a:lvl6pPr marL="457200" algn="ctr" defTabSz="912813" rtl="0" fontAlgn="base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Arial" charset="0"/>
          <a:ea typeface="ＭＳ Ｐゴシック" charset="-128"/>
        </a:defRPr>
      </a:lvl6pPr>
      <a:lvl7pPr marL="914400" algn="ctr" defTabSz="912813" rtl="0" fontAlgn="base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Arial" charset="0"/>
          <a:ea typeface="ＭＳ Ｐゴシック" charset="-128"/>
        </a:defRPr>
      </a:lvl7pPr>
      <a:lvl8pPr marL="1371600" algn="ctr" defTabSz="912813" rtl="0" fontAlgn="base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Arial" charset="0"/>
          <a:ea typeface="ＭＳ Ｐゴシック" charset="-128"/>
        </a:defRPr>
      </a:lvl8pPr>
      <a:lvl9pPr marL="1828800" algn="ctr" defTabSz="912813" rtl="0" fontAlgn="base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Arial" charset="0"/>
          <a:ea typeface="ＭＳ Ｐゴシック" charset="-128"/>
        </a:defRPr>
      </a:lvl9pPr>
    </p:titleStyle>
    <p:bodyStyle>
      <a:lvl1pPr marL="342900" indent="-342900" algn="l" defTabSz="912813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4163" algn="l" defTabSz="912813" rtl="0" eaLnBrk="0" fontAlgn="base" hangingPunct="0">
        <a:spcBef>
          <a:spcPct val="20000"/>
        </a:spcBef>
        <a:spcAft>
          <a:spcPct val="0"/>
        </a:spcAft>
        <a:buChar char="–"/>
        <a:defRPr kumimoji="1" sz="2700">
          <a:solidFill>
            <a:schemeClr val="tx1"/>
          </a:solidFill>
          <a:latin typeface="+mn-lt"/>
          <a:ea typeface="+mn-ea"/>
        </a:defRPr>
      </a:lvl2pPr>
      <a:lvl3pPr marL="1143000" indent="-230188" algn="l" defTabSz="912813" rtl="0" eaLnBrk="0" fontAlgn="base" hangingPunct="0">
        <a:spcBef>
          <a:spcPct val="20000"/>
        </a:spcBef>
        <a:spcAft>
          <a:spcPct val="0"/>
        </a:spcAft>
        <a:buChar char="•"/>
        <a:defRPr kumimoji="1" sz="2500">
          <a:solidFill>
            <a:schemeClr val="tx1"/>
          </a:solidFill>
          <a:latin typeface="+mn-lt"/>
          <a:ea typeface="+mn-ea"/>
        </a:defRPr>
      </a:lvl3pPr>
      <a:lvl4pPr marL="1601788" indent="-230188" algn="l" defTabSz="912813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5813" indent="-227013" algn="l" defTabSz="912813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3013" indent="-227013" algn="l" defTabSz="912813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0213" indent="-227013" algn="l" defTabSz="912813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7413" indent="-227013" algn="l" defTabSz="912813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4613" indent="-227013" algn="l" defTabSz="912813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718" name="テキスト ボックス 2"/>
          <p:cNvSpPr txBox="1">
            <a:spLocks noChangeArrowheads="1"/>
          </p:cNvSpPr>
          <p:nvPr/>
        </p:nvSpPr>
        <p:spPr bwMode="auto">
          <a:xfrm>
            <a:off x="-20905" y="0"/>
            <a:ext cx="342691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b="1" dirty="0" smtClean="0"/>
              <a:t>Supplementary Figure </a:t>
            </a:r>
            <a:r>
              <a:rPr lang="en-US" altLang="ja-JP" b="1" dirty="0" smtClean="0"/>
              <a:t>S2</a:t>
            </a:r>
            <a:endParaRPr lang="ja-JP" altLang="en-US" b="1" dirty="0"/>
          </a:p>
        </p:txBody>
      </p:sp>
      <p:pic>
        <p:nvPicPr>
          <p:cNvPr id="115720" name="図 1" descr="スクリーンショット 2013-10-02 15.52.47.png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5430838" y="3429471"/>
            <a:ext cx="4465637" cy="2663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5721" name="図 2" descr="スクリーンショット 2013-10-02 15.52.35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5430838" y="692621"/>
            <a:ext cx="4465637" cy="26654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5723" name="Text Box 33"/>
          <p:cNvSpPr txBox="1">
            <a:spLocks noChangeArrowheads="1"/>
          </p:cNvSpPr>
          <p:nvPr/>
        </p:nvSpPr>
        <p:spPr bwMode="auto">
          <a:xfrm>
            <a:off x="5430838" y="3429471"/>
            <a:ext cx="50482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000" b="1" dirty="0" smtClean="0"/>
              <a:t>d</a:t>
            </a:r>
            <a:endParaRPr lang="en-US" altLang="ja-JP" sz="2000" b="1" dirty="0"/>
          </a:p>
        </p:txBody>
      </p:sp>
      <p:sp>
        <p:nvSpPr>
          <p:cNvPr id="115724" name="Text Box 33"/>
          <p:cNvSpPr txBox="1">
            <a:spLocks noChangeArrowheads="1"/>
          </p:cNvSpPr>
          <p:nvPr/>
        </p:nvSpPr>
        <p:spPr bwMode="auto">
          <a:xfrm>
            <a:off x="5430838" y="692621"/>
            <a:ext cx="719137" cy="39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000" b="1" dirty="0" smtClean="0"/>
              <a:t>c</a:t>
            </a:r>
            <a:endParaRPr lang="en-US" altLang="ja-JP" sz="2000" b="1" dirty="0"/>
          </a:p>
        </p:txBody>
      </p:sp>
      <p:sp>
        <p:nvSpPr>
          <p:cNvPr id="115719" name="テキスト ボックス 3"/>
          <p:cNvSpPr txBox="1">
            <a:spLocks noChangeArrowheads="1"/>
          </p:cNvSpPr>
          <p:nvPr/>
        </p:nvSpPr>
        <p:spPr bwMode="auto">
          <a:xfrm>
            <a:off x="390972" y="669770"/>
            <a:ext cx="876300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2000" b="1" dirty="0" smtClean="0"/>
              <a:t>a</a:t>
            </a:r>
            <a:endParaRPr lang="ja-JP" altLang="en-US" sz="2000" b="1" dirty="0"/>
          </a:p>
        </p:txBody>
      </p:sp>
      <p:grpSp>
        <p:nvGrpSpPr>
          <p:cNvPr id="5" name="グループ化 4"/>
          <p:cNvGrpSpPr/>
          <p:nvPr/>
        </p:nvGrpSpPr>
        <p:grpSpPr>
          <a:xfrm>
            <a:off x="376551" y="3596899"/>
            <a:ext cx="4489550" cy="2496397"/>
            <a:chOff x="376551" y="3596899"/>
            <a:chExt cx="4489550" cy="2496397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35789" y="5304732"/>
              <a:ext cx="2575663" cy="27521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" name="図 19" descr="4cell ACTIN.jpg"/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2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25" t="30252" r="10505" b="21475"/>
            <a:stretch/>
          </p:blipFill>
          <p:spPr>
            <a:xfrm>
              <a:off x="2119164" y="5723964"/>
              <a:ext cx="2304256" cy="288032"/>
            </a:xfrm>
            <a:prstGeom prst="rect">
              <a:avLst/>
            </a:prstGeom>
          </p:spPr>
        </p:pic>
        <p:sp>
          <p:nvSpPr>
            <p:cNvPr id="115715" name="テキスト ボックス 5"/>
            <p:cNvSpPr txBox="1">
              <a:spLocks noChangeArrowheads="1"/>
            </p:cNvSpPr>
            <p:nvPr/>
          </p:nvSpPr>
          <p:spPr bwMode="auto">
            <a:xfrm>
              <a:off x="751012" y="5219908"/>
              <a:ext cx="1152525" cy="368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ja-JP" dirty="0"/>
                <a:t>NSMCE2</a:t>
              </a:r>
              <a:endParaRPr lang="ja-JP" altLang="en-US" dirty="0"/>
            </a:p>
          </p:txBody>
        </p:sp>
        <p:sp>
          <p:nvSpPr>
            <p:cNvPr id="115716" name="テキスト ボックス 6"/>
            <p:cNvSpPr txBox="1">
              <a:spLocks noChangeArrowheads="1"/>
            </p:cNvSpPr>
            <p:nvPr/>
          </p:nvSpPr>
          <p:spPr bwMode="auto">
            <a:xfrm>
              <a:off x="751012" y="5651956"/>
              <a:ext cx="1152525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ja-JP" dirty="0" smtClean="0">
                  <a:latin typeface="Symbol" pitchFamily="18" charset="2"/>
                </a:rPr>
                <a:t>b</a:t>
              </a:r>
              <a:r>
                <a:rPr lang="en-US" altLang="ja-JP" dirty="0" smtClean="0"/>
                <a:t>-ACTIN</a:t>
              </a:r>
              <a:endParaRPr lang="ja-JP" altLang="en-US" dirty="0"/>
            </a:p>
          </p:txBody>
        </p:sp>
        <p:sp>
          <p:nvSpPr>
            <p:cNvPr id="17" name="正方形/長方形 16"/>
            <p:cNvSpPr/>
            <p:nvPr/>
          </p:nvSpPr>
          <p:spPr>
            <a:xfrm>
              <a:off x="2119164" y="5287352"/>
              <a:ext cx="1800200" cy="292596"/>
            </a:xfrm>
            <a:prstGeom prst="rect">
              <a:avLst/>
            </a:prstGeom>
            <a:noFill/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9" name="正方形/長方形 18"/>
            <p:cNvSpPr/>
            <p:nvPr/>
          </p:nvSpPr>
          <p:spPr>
            <a:xfrm>
              <a:off x="2119164" y="5719398"/>
              <a:ext cx="1800200" cy="291075"/>
            </a:xfrm>
            <a:prstGeom prst="rect">
              <a:avLst/>
            </a:prstGeom>
            <a:noFill/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6" name="テキスト ボックス 3"/>
            <p:cNvSpPr txBox="1">
              <a:spLocks noChangeArrowheads="1"/>
            </p:cNvSpPr>
            <p:nvPr/>
          </p:nvSpPr>
          <p:spPr bwMode="auto">
            <a:xfrm>
              <a:off x="376551" y="3841750"/>
              <a:ext cx="876300" cy="4000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ja-JP" sz="2000" b="1" dirty="0" smtClean="0"/>
                <a:t>b</a:t>
              </a:r>
              <a:endParaRPr lang="ja-JP" altLang="en-US" sz="2000" b="1" dirty="0"/>
            </a:p>
          </p:txBody>
        </p:sp>
        <p:sp>
          <p:nvSpPr>
            <p:cNvPr id="3" name="テキスト ボックス 2"/>
            <p:cNvSpPr txBox="1"/>
            <p:nvPr/>
          </p:nvSpPr>
          <p:spPr>
            <a:xfrm rot="16200000">
              <a:off x="1582025" y="4261309"/>
              <a:ext cx="16723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 smtClean="0"/>
                <a:t>Normal BM</a:t>
              </a:r>
              <a:endParaRPr kumimoji="1" lang="ja-JP" altLang="en-US" dirty="0"/>
            </a:p>
          </p:txBody>
        </p:sp>
        <p:sp>
          <p:nvSpPr>
            <p:cNvPr id="48" name="テキスト ボックス 47"/>
            <p:cNvSpPr txBox="1"/>
            <p:nvPr/>
          </p:nvSpPr>
          <p:spPr>
            <a:xfrm rot="16200000">
              <a:off x="2163724" y="4254863"/>
              <a:ext cx="16723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 smtClean="0"/>
                <a:t>KG1</a:t>
              </a:r>
              <a:endParaRPr kumimoji="1" lang="ja-JP" altLang="en-US" dirty="0"/>
            </a:p>
          </p:txBody>
        </p:sp>
        <p:sp>
          <p:nvSpPr>
            <p:cNvPr id="49" name="テキスト ボックス 48"/>
            <p:cNvSpPr txBox="1"/>
            <p:nvPr/>
          </p:nvSpPr>
          <p:spPr>
            <a:xfrm rot="16200000">
              <a:off x="2754499" y="4248416"/>
              <a:ext cx="16723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 smtClean="0"/>
                <a:t>HL60</a:t>
              </a:r>
              <a:endParaRPr kumimoji="1" lang="ja-JP" altLang="en-US" dirty="0"/>
            </a:p>
          </p:txBody>
        </p:sp>
        <p:sp>
          <p:nvSpPr>
            <p:cNvPr id="4" name="正方形/長方形 3"/>
            <p:cNvSpPr/>
            <p:nvPr/>
          </p:nvSpPr>
          <p:spPr>
            <a:xfrm>
              <a:off x="3929997" y="5219908"/>
              <a:ext cx="936104" cy="8733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aphicFrame>
        <p:nvGraphicFramePr>
          <p:cNvPr id="21" name="グラフ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50266036"/>
              </p:ext>
            </p:extLst>
          </p:nvPr>
        </p:nvGraphicFramePr>
        <p:xfrm>
          <a:off x="591077" y="764704"/>
          <a:ext cx="4480415" cy="30648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32378196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4_標準デザイン">
  <a:themeElements>
    <a:clrScheme name="4_標準デザイ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4_標準デザイ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>
          <a:solidFill>
            <a:schemeClr val="tx1">
              <a:lumMod val="50000"/>
              <a:lumOff val="50000"/>
            </a:schemeClr>
          </a:solidFill>
        </a:ln>
        <a:effectLst/>
      </a:spPr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>
    <a:extraClrScheme>
      <a:clrScheme name="4_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4_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4_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4_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4_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4_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23</TotalTime>
  <Words>13</Words>
  <Application>Microsoft Office PowerPoint</Application>
  <PresentationFormat>35mm スライド</PresentationFormat>
  <Paragraphs>1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4_標準デザイ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谷脇</dc:creator>
  <cp:lastModifiedBy>Windows ユーザー</cp:lastModifiedBy>
  <cp:revision>401</cp:revision>
  <dcterms:created xsi:type="dcterms:W3CDTF">2012-11-30T04:34:21Z</dcterms:created>
  <dcterms:modified xsi:type="dcterms:W3CDTF">2014-08-30T07:22:11Z</dcterms:modified>
</cp:coreProperties>
</file>